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9" r:id="rId11"/>
    <p:sldId id="273" r:id="rId12"/>
    <p:sldId id="267" r:id="rId13"/>
    <p:sldId id="268" r:id="rId14"/>
    <p:sldId id="270" r:id="rId15"/>
    <p:sldId id="271" r:id="rId16"/>
    <p:sldId id="272" r:id="rId17"/>
    <p:sldId id="265" r:id="rId18"/>
    <p:sldId id="266" r:id="rId1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3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4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99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228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1460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330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314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431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6016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3366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31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85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9873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48FCB-FD3B-4F97-B035-4504872089F1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8D956-DDE0-46E7-8CC0-C93D8D2526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496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jpeg"/><Relationship Id="rId3" Type="http://schemas.openxmlformats.org/officeDocument/2006/relationships/image" Target="../media/image43.jpeg"/><Relationship Id="rId7" Type="http://schemas.openxmlformats.org/officeDocument/2006/relationships/image" Target="../media/image47.jpeg"/><Relationship Id="rId2" Type="http://schemas.openxmlformats.org/officeDocument/2006/relationships/image" Target="../media/image4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jpeg"/><Relationship Id="rId5" Type="http://schemas.openxmlformats.org/officeDocument/2006/relationships/image" Target="../media/image45.jpeg"/><Relationship Id="rId4" Type="http://schemas.openxmlformats.org/officeDocument/2006/relationships/image" Target="../media/image44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tif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Relationship Id="rId9" Type="http://schemas.openxmlformats.org/officeDocument/2006/relationships/image" Target="../media/image56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0.png"/><Relationship Id="rId4" Type="http://schemas.openxmlformats.org/officeDocument/2006/relationships/image" Target="../media/image5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3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4" Type="http://schemas.openxmlformats.org/officeDocument/2006/relationships/image" Target="../media/image66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png"/><Relationship Id="rId3" Type="http://schemas.openxmlformats.org/officeDocument/2006/relationships/image" Target="../media/image70.png"/><Relationship Id="rId7" Type="http://schemas.openxmlformats.org/officeDocument/2006/relationships/image" Target="../media/image74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png"/><Relationship Id="rId3" Type="http://schemas.openxmlformats.org/officeDocument/2006/relationships/image" Target="../media/image77.png"/><Relationship Id="rId7" Type="http://schemas.openxmlformats.org/officeDocument/2006/relationships/image" Target="../media/image81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7.tiff"/><Relationship Id="rId5" Type="http://schemas.openxmlformats.org/officeDocument/2006/relationships/image" Target="../media/image86.png"/><Relationship Id="rId4" Type="http://schemas.openxmlformats.org/officeDocument/2006/relationships/image" Target="../media/image8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jpeg"/><Relationship Id="rId4" Type="http://schemas.openxmlformats.org/officeDocument/2006/relationships/image" Target="../media/image33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7242D936-1E38-4AFD-80E1-2C4CCD7E67B1}"/>
              </a:ext>
            </a:extLst>
          </p:cNvPr>
          <p:cNvGrpSpPr/>
          <p:nvPr/>
        </p:nvGrpSpPr>
        <p:grpSpPr>
          <a:xfrm>
            <a:off x="1640955" y="2301949"/>
            <a:ext cx="2961937" cy="2002634"/>
            <a:chOff x="579397" y="1154637"/>
            <a:chExt cx="7735824" cy="5230368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E8F4160-1945-4EB8-B4EF-7E0CCB7F35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397" y="1154637"/>
              <a:ext cx="7735824" cy="52303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CDD6F161-72E9-4588-9A92-833E0DC397BE}"/>
                </a:ext>
              </a:extLst>
            </p:cNvPr>
            <p:cNvSpPr/>
            <p:nvPr/>
          </p:nvSpPr>
          <p:spPr>
            <a:xfrm>
              <a:off x="5170516" y="2892829"/>
              <a:ext cx="3059084" cy="14048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5B6A48C1-0C31-4989-A794-1FA0C3E2AC9C}"/>
              </a:ext>
            </a:extLst>
          </p:cNvPr>
          <p:cNvSpPr txBox="1"/>
          <p:nvPr/>
        </p:nvSpPr>
        <p:spPr>
          <a:xfrm>
            <a:off x="4039894" y="472995"/>
            <a:ext cx="12442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D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71A6BFD4-716E-4814-810A-240E1C50B684}"/>
              </a:ext>
            </a:extLst>
          </p:cNvPr>
          <p:cNvGrpSpPr/>
          <p:nvPr/>
        </p:nvGrpSpPr>
        <p:grpSpPr>
          <a:xfrm>
            <a:off x="6077973" y="2301949"/>
            <a:ext cx="1350717" cy="2002634"/>
            <a:chOff x="5568832" y="1949781"/>
            <a:chExt cx="2173683" cy="2804357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C65A75E5-0664-478E-9BD1-053168CF1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8832" y="1949781"/>
              <a:ext cx="2173683" cy="28043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5C315C99-CAF6-4AC5-A60B-D57A02178CE8}"/>
                </a:ext>
              </a:extLst>
            </p:cNvPr>
            <p:cNvSpPr/>
            <p:nvPr/>
          </p:nvSpPr>
          <p:spPr>
            <a:xfrm>
              <a:off x="5669280" y="2721611"/>
              <a:ext cx="2073235" cy="112718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9" name="文本框 8"/>
          <p:cNvSpPr txBox="1"/>
          <p:nvPr/>
        </p:nvSpPr>
        <p:spPr>
          <a:xfrm>
            <a:off x="4570109" y="3070927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aseline="30000" dirty="0"/>
              <a:t>32</a:t>
            </a:r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7491108" y="2932427"/>
            <a:ext cx="11945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oomassie</a:t>
            </a:r>
            <a:endParaRPr lang="en-US" altLang="zh-CN" dirty="0"/>
          </a:p>
          <a:p>
            <a:r>
              <a:rPr lang="en-US" altLang="zh-CN" dirty="0"/>
              <a:t>blu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756757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878481" y="564333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5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3717830" y="1892959"/>
            <a:ext cx="1830354" cy="1619864"/>
            <a:chOff x="2395657" y="1892959"/>
            <a:chExt cx="1830354" cy="1619864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5657" y="1892959"/>
              <a:ext cx="1830354" cy="16198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矩形 6"/>
            <p:cNvSpPr/>
            <p:nvPr/>
          </p:nvSpPr>
          <p:spPr>
            <a:xfrm>
              <a:off x="3021227" y="2638168"/>
              <a:ext cx="1124465" cy="23477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3723467" y="3857871"/>
            <a:ext cx="1824717" cy="1474371"/>
            <a:chOff x="2401294" y="3857871"/>
            <a:chExt cx="1824717" cy="1474371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1294" y="3857871"/>
              <a:ext cx="1824717" cy="14743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矩形 8"/>
            <p:cNvSpPr/>
            <p:nvPr/>
          </p:nvSpPr>
          <p:spPr>
            <a:xfrm>
              <a:off x="3039762" y="4491681"/>
              <a:ext cx="982362" cy="30891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5613247" y="2570891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5585375" y="4431268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367972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3">
            <a:extLst>
              <a:ext uri="{FF2B5EF4-FFF2-40B4-BE49-F238E27FC236}">
                <a16:creationId xmlns:a16="http://schemas.microsoft.com/office/drawing/2014/main" id="{5547B24C-388E-482E-854C-81A336476104}"/>
              </a:ext>
            </a:extLst>
          </p:cNvPr>
          <p:cNvSpPr txBox="1"/>
          <p:nvPr/>
        </p:nvSpPr>
        <p:spPr>
          <a:xfrm>
            <a:off x="1897630" y="358004"/>
            <a:ext cx="12442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6D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3">
            <a:extLst>
              <a:ext uri="{FF2B5EF4-FFF2-40B4-BE49-F238E27FC236}">
                <a16:creationId xmlns:a16="http://schemas.microsoft.com/office/drawing/2014/main" id="{A545265F-3E01-40E5-9C0F-4CC7EA0E9C63}"/>
              </a:ext>
            </a:extLst>
          </p:cNvPr>
          <p:cNvSpPr txBox="1"/>
          <p:nvPr/>
        </p:nvSpPr>
        <p:spPr>
          <a:xfrm>
            <a:off x="6679824" y="354102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6K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aphic 8">
            <a:extLst>
              <a:ext uri="{FF2B5EF4-FFF2-40B4-BE49-F238E27FC236}">
                <a16:creationId xmlns:a16="http://schemas.microsoft.com/office/drawing/2014/main" id="{342DF6BB-DEA8-49A9-950B-367ED9E987EA}"/>
              </a:ext>
            </a:extLst>
          </p:cNvPr>
          <p:cNvGrpSpPr/>
          <p:nvPr/>
        </p:nvGrpSpPr>
        <p:grpSpPr>
          <a:xfrm>
            <a:off x="83515" y="1302228"/>
            <a:ext cx="2079775" cy="2329174"/>
            <a:chOff x="2845836" y="2216389"/>
            <a:chExt cx="1237297" cy="1403319"/>
          </a:xfrm>
          <a:noFill/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54278ED-D4A6-474C-A90A-2D70062391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45836" y="2216719"/>
              <a:ext cx="1237235" cy="1402989"/>
            </a:xfrm>
            <a:custGeom>
              <a:avLst/>
              <a:gdLst>
                <a:gd name="connsiteX0" fmla="*/ -39 w 1237235"/>
                <a:gd name="connsiteY0" fmla="*/ -31 h 1402989"/>
                <a:gd name="connsiteX1" fmla="*/ 1237197 w 1237235"/>
                <a:gd name="connsiteY1" fmla="*/ -31 h 1402989"/>
                <a:gd name="connsiteX2" fmla="*/ 1237197 w 1237235"/>
                <a:gd name="connsiteY2" fmla="*/ 1402959 h 1402989"/>
                <a:gd name="connsiteX3" fmla="*/ -39 w 1237235"/>
                <a:gd name="connsiteY3" fmla="*/ 1402959 h 14029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237235" h="1402989">
                  <a:moveTo>
                    <a:pt x="-39" y="-31"/>
                  </a:moveTo>
                  <a:lnTo>
                    <a:pt x="1237197" y="-31"/>
                  </a:lnTo>
                  <a:lnTo>
                    <a:pt x="1237197" y="1402959"/>
                  </a:lnTo>
                  <a:lnTo>
                    <a:pt x="-39" y="1402959"/>
                  </a:lnTo>
                  <a:close/>
                </a:path>
              </a:pathLst>
            </a:custGeom>
          </p:spPr>
        </p:pic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3EBC5E7D-7527-4B68-860F-5F456FA17FFE}"/>
                </a:ext>
              </a:extLst>
            </p:cNvPr>
            <p:cNvSpPr/>
            <p:nvPr/>
          </p:nvSpPr>
          <p:spPr>
            <a:xfrm>
              <a:off x="2845836" y="2216389"/>
              <a:ext cx="1237297" cy="1403032"/>
            </a:xfrm>
            <a:custGeom>
              <a:avLst/>
              <a:gdLst>
                <a:gd name="connsiteX0" fmla="*/ 0 w 1237297"/>
                <a:gd name="connsiteY0" fmla="*/ 0 h 1403032"/>
                <a:gd name="connsiteX1" fmla="*/ 1237298 w 1237297"/>
                <a:gd name="connsiteY1" fmla="*/ 0 h 1403032"/>
                <a:gd name="connsiteX2" fmla="*/ 1237298 w 1237297"/>
                <a:gd name="connsiteY2" fmla="*/ 1403033 h 1403032"/>
                <a:gd name="connsiteX3" fmla="*/ 0 w 1237297"/>
                <a:gd name="connsiteY3" fmla="*/ 1403033 h 14030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237297" h="1403032">
                  <a:moveTo>
                    <a:pt x="0" y="0"/>
                  </a:moveTo>
                  <a:lnTo>
                    <a:pt x="1237298" y="0"/>
                  </a:lnTo>
                  <a:lnTo>
                    <a:pt x="1237298" y="1403033"/>
                  </a:lnTo>
                  <a:lnTo>
                    <a:pt x="0" y="1403033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grpSp>
        <p:nvGrpSpPr>
          <p:cNvPr id="14" name="Graphic 8">
            <a:extLst>
              <a:ext uri="{FF2B5EF4-FFF2-40B4-BE49-F238E27FC236}">
                <a16:creationId xmlns:a16="http://schemas.microsoft.com/office/drawing/2014/main" id="{342DF6BB-DEA8-49A9-950B-367ED9E987EA}"/>
              </a:ext>
            </a:extLst>
          </p:cNvPr>
          <p:cNvGrpSpPr/>
          <p:nvPr/>
        </p:nvGrpSpPr>
        <p:grpSpPr>
          <a:xfrm>
            <a:off x="3023415" y="1301264"/>
            <a:ext cx="2169562" cy="1287677"/>
            <a:chOff x="4266890" y="2216389"/>
            <a:chExt cx="1290713" cy="775821"/>
          </a:xfrm>
          <a:noFill/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AA96CC6-8A5B-4031-9FCC-167E7EC7B03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66890" y="2216719"/>
              <a:ext cx="1290513" cy="775492"/>
            </a:xfrm>
            <a:custGeom>
              <a:avLst/>
              <a:gdLst>
                <a:gd name="connsiteX0" fmla="*/ 108 w 1290513"/>
                <a:gd name="connsiteY0" fmla="*/ -11 h 775492"/>
                <a:gd name="connsiteX1" fmla="*/ 1290622 w 1290513"/>
                <a:gd name="connsiteY1" fmla="*/ -11 h 775492"/>
                <a:gd name="connsiteX2" fmla="*/ 1290622 w 1290513"/>
                <a:gd name="connsiteY2" fmla="*/ 775482 h 775492"/>
                <a:gd name="connsiteX3" fmla="*/ 108 w 1290513"/>
                <a:gd name="connsiteY3" fmla="*/ 775482 h 7754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290513" h="775492">
                  <a:moveTo>
                    <a:pt x="108" y="-11"/>
                  </a:moveTo>
                  <a:lnTo>
                    <a:pt x="1290622" y="-11"/>
                  </a:lnTo>
                  <a:lnTo>
                    <a:pt x="1290622" y="775482"/>
                  </a:lnTo>
                  <a:lnTo>
                    <a:pt x="108" y="775482"/>
                  </a:lnTo>
                  <a:close/>
                </a:path>
              </a:pathLst>
            </a:custGeom>
          </p:spPr>
        </p:pic>
        <p:sp>
          <p:nvSpPr>
            <p:cNvPr id="16" name="Freeform: Shape 15">
              <a:extLst>
                <a:ext uri="{FF2B5EF4-FFF2-40B4-BE49-F238E27FC236}">
                  <a16:creationId xmlns:a16="http://schemas.microsoft.com/office/drawing/2014/main" id="{C08BFF47-9D1E-4A20-8B76-B05753CE40AA}"/>
                </a:ext>
              </a:extLst>
            </p:cNvPr>
            <p:cNvSpPr/>
            <p:nvPr/>
          </p:nvSpPr>
          <p:spPr>
            <a:xfrm>
              <a:off x="4266966" y="2216389"/>
              <a:ext cx="1290637" cy="775335"/>
            </a:xfrm>
            <a:custGeom>
              <a:avLst/>
              <a:gdLst>
                <a:gd name="connsiteX0" fmla="*/ 0 w 1290637"/>
                <a:gd name="connsiteY0" fmla="*/ 0 h 775335"/>
                <a:gd name="connsiteX1" fmla="*/ 1290638 w 1290637"/>
                <a:gd name="connsiteY1" fmla="*/ 0 h 775335"/>
                <a:gd name="connsiteX2" fmla="*/ 1290638 w 1290637"/>
                <a:gd name="connsiteY2" fmla="*/ 775335 h 775335"/>
                <a:gd name="connsiteX3" fmla="*/ 0 w 1290637"/>
                <a:gd name="connsiteY3" fmla="*/ 775335 h 7753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290637" h="775335">
                  <a:moveTo>
                    <a:pt x="0" y="0"/>
                  </a:moveTo>
                  <a:lnTo>
                    <a:pt x="1290638" y="0"/>
                  </a:lnTo>
                  <a:lnTo>
                    <a:pt x="1290638" y="775335"/>
                  </a:lnTo>
                  <a:lnTo>
                    <a:pt x="0" y="775335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grpSp>
        <p:nvGrpSpPr>
          <p:cNvPr id="17" name="Graphic 8">
            <a:extLst>
              <a:ext uri="{FF2B5EF4-FFF2-40B4-BE49-F238E27FC236}">
                <a16:creationId xmlns:a16="http://schemas.microsoft.com/office/drawing/2014/main" id="{342DF6BB-DEA8-49A9-950B-367ED9E987EA}"/>
              </a:ext>
            </a:extLst>
          </p:cNvPr>
          <p:cNvGrpSpPr/>
          <p:nvPr/>
        </p:nvGrpSpPr>
        <p:grpSpPr>
          <a:xfrm>
            <a:off x="2999239" y="3134754"/>
            <a:ext cx="2217754" cy="1396333"/>
            <a:chOff x="4252507" y="3321060"/>
            <a:chExt cx="1319383" cy="841286"/>
          </a:xfrm>
          <a:noFill/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1C6F384-1471-4C5B-BFA2-D87FD26448C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52507" y="3321060"/>
              <a:ext cx="1319298" cy="840651"/>
            </a:xfrm>
            <a:custGeom>
              <a:avLst/>
              <a:gdLst>
                <a:gd name="connsiteX0" fmla="*/ 100 w 1319298"/>
                <a:gd name="connsiteY0" fmla="*/ 97 h 840651"/>
                <a:gd name="connsiteX1" fmla="*/ 1319398 w 1319298"/>
                <a:gd name="connsiteY1" fmla="*/ 97 h 840651"/>
                <a:gd name="connsiteX2" fmla="*/ 1319398 w 1319298"/>
                <a:gd name="connsiteY2" fmla="*/ 840749 h 840651"/>
                <a:gd name="connsiteX3" fmla="*/ 100 w 1319298"/>
                <a:gd name="connsiteY3" fmla="*/ 840749 h 8406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19298" h="840651">
                  <a:moveTo>
                    <a:pt x="100" y="97"/>
                  </a:moveTo>
                  <a:lnTo>
                    <a:pt x="1319398" y="97"/>
                  </a:lnTo>
                  <a:lnTo>
                    <a:pt x="1319398" y="840749"/>
                  </a:lnTo>
                  <a:lnTo>
                    <a:pt x="100" y="840749"/>
                  </a:lnTo>
                  <a:close/>
                </a:path>
              </a:pathLst>
            </a:custGeom>
          </p:spPr>
        </p:pic>
        <p:sp>
          <p:nvSpPr>
            <p:cNvPr id="19" name="Freeform: Shape 18">
              <a:extLst>
                <a:ext uri="{FF2B5EF4-FFF2-40B4-BE49-F238E27FC236}">
                  <a16:creationId xmlns:a16="http://schemas.microsoft.com/office/drawing/2014/main" id="{A538824B-EE88-487F-92F1-1F0071C7BD52}"/>
                </a:ext>
              </a:extLst>
            </p:cNvPr>
            <p:cNvSpPr/>
            <p:nvPr/>
          </p:nvSpPr>
          <p:spPr>
            <a:xfrm>
              <a:off x="4252679" y="3321289"/>
              <a:ext cx="1319212" cy="841057"/>
            </a:xfrm>
            <a:custGeom>
              <a:avLst/>
              <a:gdLst>
                <a:gd name="connsiteX0" fmla="*/ 0 w 1319212"/>
                <a:gd name="connsiteY0" fmla="*/ 0 h 841057"/>
                <a:gd name="connsiteX1" fmla="*/ 1319213 w 1319212"/>
                <a:gd name="connsiteY1" fmla="*/ 0 h 841057"/>
                <a:gd name="connsiteX2" fmla="*/ 1319213 w 1319212"/>
                <a:gd name="connsiteY2" fmla="*/ 841058 h 841057"/>
                <a:gd name="connsiteX3" fmla="*/ 0 w 1319212"/>
                <a:gd name="connsiteY3" fmla="*/ 841058 h 8410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19212" h="841057">
                  <a:moveTo>
                    <a:pt x="0" y="0"/>
                  </a:moveTo>
                  <a:lnTo>
                    <a:pt x="1319213" y="0"/>
                  </a:lnTo>
                  <a:lnTo>
                    <a:pt x="1319213" y="841058"/>
                  </a:lnTo>
                  <a:lnTo>
                    <a:pt x="0" y="841058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grpSp>
        <p:nvGrpSpPr>
          <p:cNvPr id="20" name="Graphic 8">
            <a:extLst>
              <a:ext uri="{FF2B5EF4-FFF2-40B4-BE49-F238E27FC236}">
                <a16:creationId xmlns:a16="http://schemas.microsoft.com/office/drawing/2014/main" id="{342DF6BB-DEA8-49A9-950B-367ED9E987EA}"/>
              </a:ext>
            </a:extLst>
          </p:cNvPr>
          <p:cNvGrpSpPr/>
          <p:nvPr/>
        </p:nvGrpSpPr>
        <p:grpSpPr>
          <a:xfrm>
            <a:off x="2978649" y="4957938"/>
            <a:ext cx="2259158" cy="1199303"/>
            <a:chOff x="4240258" y="4419522"/>
            <a:chExt cx="1344015" cy="722576"/>
          </a:xfrm>
          <a:noFill/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155CA6F-B0EA-4A6D-ACAC-486FE412C0A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40258" y="4419883"/>
              <a:ext cx="1343791" cy="722214"/>
            </a:xfrm>
            <a:custGeom>
              <a:avLst/>
              <a:gdLst>
                <a:gd name="connsiteX0" fmla="*/ 104 w 1343791"/>
                <a:gd name="connsiteY0" fmla="*/ 222 h 722214"/>
                <a:gd name="connsiteX1" fmla="*/ 1343896 w 1343791"/>
                <a:gd name="connsiteY1" fmla="*/ 222 h 722214"/>
                <a:gd name="connsiteX2" fmla="*/ 1343896 w 1343791"/>
                <a:gd name="connsiteY2" fmla="*/ 722436 h 722214"/>
                <a:gd name="connsiteX3" fmla="*/ 104 w 1343791"/>
                <a:gd name="connsiteY3" fmla="*/ 722436 h 7222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43791" h="722214">
                  <a:moveTo>
                    <a:pt x="104" y="222"/>
                  </a:moveTo>
                  <a:lnTo>
                    <a:pt x="1343896" y="222"/>
                  </a:lnTo>
                  <a:lnTo>
                    <a:pt x="1343896" y="722436"/>
                  </a:lnTo>
                  <a:lnTo>
                    <a:pt x="104" y="722436"/>
                  </a:lnTo>
                  <a:close/>
                </a:path>
              </a:pathLst>
            </a:custGeom>
          </p:spPr>
        </p:pic>
        <p:sp>
          <p:nvSpPr>
            <p:cNvPr id="22" name="Freeform: Shape 21">
              <a:extLst>
                <a:ext uri="{FF2B5EF4-FFF2-40B4-BE49-F238E27FC236}">
                  <a16:creationId xmlns:a16="http://schemas.microsoft.com/office/drawing/2014/main" id="{E4D033C9-2D68-4F74-A410-2602D8639224}"/>
                </a:ext>
              </a:extLst>
            </p:cNvPr>
            <p:cNvSpPr/>
            <p:nvPr/>
          </p:nvSpPr>
          <p:spPr>
            <a:xfrm>
              <a:off x="4240296" y="4419522"/>
              <a:ext cx="1343977" cy="721994"/>
            </a:xfrm>
            <a:custGeom>
              <a:avLst/>
              <a:gdLst>
                <a:gd name="connsiteX0" fmla="*/ 0 w 1343977"/>
                <a:gd name="connsiteY0" fmla="*/ 0 h 721994"/>
                <a:gd name="connsiteX1" fmla="*/ 1343978 w 1343977"/>
                <a:gd name="connsiteY1" fmla="*/ 0 h 721994"/>
                <a:gd name="connsiteX2" fmla="*/ 1343978 w 1343977"/>
                <a:gd name="connsiteY2" fmla="*/ 721995 h 721994"/>
                <a:gd name="connsiteX3" fmla="*/ 0 w 1343977"/>
                <a:gd name="connsiteY3" fmla="*/ 721995 h 7219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43977" h="721994">
                  <a:moveTo>
                    <a:pt x="0" y="0"/>
                  </a:moveTo>
                  <a:lnTo>
                    <a:pt x="1343978" y="0"/>
                  </a:lnTo>
                  <a:lnTo>
                    <a:pt x="1343978" y="721995"/>
                  </a:lnTo>
                  <a:lnTo>
                    <a:pt x="0" y="721995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grpSp>
        <p:nvGrpSpPr>
          <p:cNvPr id="23" name="Graphic 8">
            <a:extLst>
              <a:ext uri="{FF2B5EF4-FFF2-40B4-BE49-F238E27FC236}">
                <a16:creationId xmlns:a16="http://schemas.microsoft.com/office/drawing/2014/main" id="{342DF6BB-DEA8-49A9-950B-367ED9E987EA}"/>
              </a:ext>
            </a:extLst>
          </p:cNvPr>
          <p:cNvGrpSpPr/>
          <p:nvPr/>
        </p:nvGrpSpPr>
        <p:grpSpPr>
          <a:xfrm>
            <a:off x="83515" y="4045129"/>
            <a:ext cx="1970903" cy="2113068"/>
            <a:chOff x="2845836" y="3868977"/>
            <a:chExt cx="1172527" cy="1273116"/>
          </a:xfrm>
          <a:noFill/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A17FBD4A-9C95-41D5-B53E-BCEB50BF2D9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45836" y="3869338"/>
              <a:ext cx="1172117" cy="1272754"/>
            </a:xfrm>
            <a:custGeom>
              <a:avLst/>
              <a:gdLst>
                <a:gd name="connsiteX0" fmla="*/ -37 w 1172117"/>
                <a:gd name="connsiteY0" fmla="*/ 147 h 1272754"/>
                <a:gd name="connsiteX1" fmla="*/ 1172081 w 1172117"/>
                <a:gd name="connsiteY1" fmla="*/ 147 h 1272754"/>
                <a:gd name="connsiteX2" fmla="*/ 1172081 w 1172117"/>
                <a:gd name="connsiteY2" fmla="*/ 1272901 h 1272754"/>
                <a:gd name="connsiteX3" fmla="*/ -37 w 1172117"/>
                <a:gd name="connsiteY3" fmla="*/ 1272901 h 12727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72117" h="1272754">
                  <a:moveTo>
                    <a:pt x="-37" y="147"/>
                  </a:moveTo>
                  <a:lnTo>
                    <a:pt x="1172081" y="147"/>
                  </a:lnTo>
                  <a:lnTo>
                    <a:pt x="1172081" y="1272901"/>
                  </a:lnTo>
                  <a:lnTo>
                    <a:pt x="-37" y="1272901"/>
                  </a:lnTo>
                  <a:close/>
                </a:path>
              </a:pathLst>
            </a:custGeom>
          </p:spPr>
        </p:pic>
        <p:sp>
          <p:nvSpPr>
            <p:cNvPr id="25" name="Freeform: Shape 24">
              <a:extLst>
                <a:ext uri="{FF2B5EF4-FFF2-40B4-BE49-F238E27FC236}">
                  <a16:creationId xmlns:a16="http://schemas.microsoft.com/office/drawing/2014/main" id="{C124BE5B-07A6-4715-8823-1477DC67F149}"/>
                </a:ext>
              </a:extLst>
            </p:cNvPr>
            <p:cNvSpPr/>
            <p:nvPr/>
          </p:nvSpPr>
          <p:spPr>
            <a:xfrm>
              <a:off x="2845836" y="3868977"/>
              <a:ext cx="1172527" cy="1272540"/>
            </a:xfrm>
            <a:custGeom>
              <a:avLst/>
              <a:gdLst>
                <a:gd name="connsiteX0" fmla="*/ 0 w 1172527"/>
                <a:gd name="connsiteY0" fmla="*/ 0 h 1272540"/>
                <a:gd name="connsiteX1" fmla="*/ 1172528 w 1172527"/>
                <a:gd name="connsiteY1" fmla="*/ 0 h 1272540"/>
                <a:gd name="connsiteX2" fmla="*/ 1172528 w 1172527"/>
                <a:gd name="connsiteY2" fmla="*/ 1272540 h 1272540"/>
                <a:gd name="connsiteX3" fmla="*/ 0 w 1172527"/>
                <a:gd name="connsiteY3" fmla="*/ 1272540 h 12725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72527" h="1272540">
                  <a:moveTo>
                    <a:pt x="0" y="0"/>
                  </a:moveTo>
                  <a:lnTo>
                    <a:pt x="1172528" y="0"/>
                  </a:lnTo>
                  <a:lnTo>
                    <a:pt x="1172528" y="1272540"/>
                  </a:lnTo>
                  <a:lnTo>
                    <a:pt x="0" y="127254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35" name="文本框 7">
            <a:extLst>
              <a:ext uri="{FF2B5EF4-FFF2-40B4-BE49-F238E27FC236}">
                <a16:creationId xmlns:a16="http://schemas.microsoft.com/office/drawing/2014/main" id="{F36587C2-95CA-4672-8EB8-07B199999DD9}"/>
              </a:ext>
            </a:extLst>
          </p:cNvPr>
          <p:cNvSpPr txBox="1"/>
          <p:nvPr/>
        </p:nvSpPr>
        <p:spPr>
          <a:xfrm>
            <a:off x="2174397" y="2132187"/>
            <a:ext cx="967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37" name="文本框 8">
            <a:extLst>
              <a:ext uri="{FF2B5EF4-FFF2-40B4-BE49-F238E27FC236}">
                <a16:creationId xmlns:a16="http://schemas.microsoft.com/office/drawing/2014/main" id="{4EF791EC-4AD6-4E65-AC91-4577DAD86523}"/>
              </a:ext>
            </a:extLst>
          </p:cNvPr>
          <p:cNvSpPr txBox="1"/>
          <p:nvPr/>
        </p:nvSpPr>
        <p:spPr>
          <a:xfrm>
            <a:off x="2078899" y="469043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39" name="文本框 8">
            <a:extLst>
              <a:ext uri="{FF2B5EF4-FFF2-40B4-BE49-F238E27FC236}">
                <a16:creationId xmlns:a16="http://schemas.microsoft.com/office/drawing/2014/main" id="{569C812E-B289-482F-8C35-1C75C421733A}"/>
              </a:ext>
            </a:extLst>
          </p:cNvPr>
          <p:cNvSpPr txBox="1"/>
          <p:nvPr/>
        </p:nvSpPr>
        <p:spPr>
          <a:xfrm>
            <a:off x="5237430" y="1760033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-1</a:t>
            </a:r>
            <a:r>
              <a:rPr lang="en-US" altLang="zh-CN" dirty="0">
                <a:latin typeface="Symbol" panose="05050102010706020507" pitchFamily="18" charset="2"/>
              </a:rPr>
              <a:t>a</a:t>
            </a:r>
            <a:endParaRPr lang="zh-CN" altLang="en-US" dirty="0"/>
          </a:p>
        </p:txBody>
      </p:sp>
      <p:sp>
        <p:nvSpPr>
          <p:cNvPr id="41" name="文本框 7">
            <a:extLst>
              <a:ext uri="{FF2B5EF4-FFF2-40B4-BE49-F238E27FC236}">
                <a16:creationId xmlns:a16="http://schemas.microsoft.com/office/drawing/2014/main" id="{1AEF7ECB-9514-4BE1-AED8-56C211A9A78F}"/>
              </a:ext>
            </a:extLst>
          </p:cNvPr>
          <p:cNvSpPr txBox="1"/>
          <p:nvPr/>
        </p:nvSpPr>
        <p:spPr>
          <a:xfrm>
            <a:off x="5237430" y="3729514"/>
            <a:ext cx="967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VEGFA</a:t>
            </a:r>
            <a:endParaRPr lang="zh-CN" altLang="en-US" dirty="0"/>
          </a:p>
        </p:txBody>
      </p:sp>
      <p:sp>
        <p:nvSpPr>
          <p:cNvPr id="43" name="文本框 7">
            <a:extLst>
              <a:ext uri="{FF2B5EF4-FFF2-40B4-BE49-F238E27FC236}">
                <a16:creationId xmlns:a16="http://schemas.microsoft.com/office/drawing/2014/main" id="{71134517-4A60-4E05-9E4A-61B8E99BD180}"/>
              </a:ext>
            </a:extLst>
          </p:cNvPr>
          <p:cNvSpPr txBox="1"/>
          <p:nvPr/>
        </p:nvSpPr>
        <p:spPr>
          <a:xfrm>
            <a:off x="5237430" y="5240164"/>
            <a:ext cx="967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h5</a:t>
            </a:r>
            <a:endParaRPr lang="zh-CN" altLang="en-US" dirty="0"/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C4581306-5096-47EC-9B85-C1DA136FF0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33461" y="3959859"/>
            <a:ext cx="1916138" cy="2100308"/>
          </a:xfrm>
          <a:custGeom>
            <a:avLst/>
            <a:gdLst>
              <a:gd name="connsiteX0" fmla="*/ 160 w 1376170"/>
              <a:gd name="connsiteY0" fmla="*/ -9 h 1508441"/>
              <a:gd name="connsiteX1" fmla="*/ 1376330 w 1376170"/>
              <a:gd name="connsiteY1" fmla="*/ -9 h 1508441"/>
              <a:gd name="connsiteX2" fmla="*/ 1376330 w 1376170"/>
              <a:gd name="connsiteY2" fmla="*/ 1508433 h 1508441"/>
              <a:gd name="connsiteX3" fmla="*/ 160 w 1376170"/>
              <a:gd name="connsiteY3" fmla="*/ 1508433 h 15084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76170" h="1508441">
                <a:moveTo>
                  <a:pt x="160" y="-9"/>
                </a:moveTo>
                <a:lnTo>
                  <a:pt x="1376330" y="-9"/>
                </a:lnTo>
                <a:lnTo>
                  <a:pt x="1376330" y="1508433"/>
                </a:lnTo>
                <a:lnTo>
                  <a:pt x="160" y="1508433"/>
                </a:lnTo>
                <a:close/>
              </a:path>
            </a:pathLst>
          </a:cu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BA2BE06-87CB-4FF6-8BF9-66C010827A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15118" y="1202866"/>
            <a:ext cx="2051915" cy="2226134"/>
          </a:xfrm>
          <a:custGeom>
            <a:avLst/>
            <a:gdLst>
              <a:gd name="connsiteX0" fmla="*/ -28 w 1473685"/>
              <a:gd name="connsiteY0" fmla="*/ -15 h 1598809"/>
              <a:gd name="connsiteX1" fmla="*/ 1473657 w 1473685"/>
              <a:gd name="connsiteY1" fmla="*/ -15 h 1598809"/>
              <a:gd name="connsiteX2" fmla="*/ 1473657 w 1473685"/>
              <a:gd name="connsiteY2" fmla="*/ 1598794 h 1598809"/>
              <a:gd name="connsiteX3" fmla="*/ -28 w 1473685"/>
              <a:gd name="connsiteY3" fmla="*/ 1598794 h 15988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73685" h="1598809">
                <a:moveTo>
                  <a:pt x="-28" y="-15"/>
                </a:moveTo>
                <a:lnTo>
                  <a:pt x="1473657" y="-15"/>
                </a:lnTo>
                <a:lnTo>
                  <a:pt x="1473657" y="1598794"/>
                </a:lnTo>
                <a:lnTo>
                  <a:pt x="-28" y="1598794"/>
                </a:lnTo>
                <a:close/>
              </a:path>
            </a:pathLst>
          </a:custGeom>
        </p:spPr>
      </p:pic>
      <p:sp>
        <p:nvSpPr>
          <p:cNvPr id="49" name="Freeform: Shape 48">
            <a:extLst>
              <a:ext uri="{FF2B5EF4-FFF2-40B4-BE49-F238E27FC236}">
                <a16:creationId xmlns:a16="http://schemas.microsoft.com/office/drawing/2014/main" id="{9943145C-BCCA-423C-801A-CC248FD7E72E}"/>
              </a:ext>
            </a:extLst>
          </p:cNvPr>
          <p:cNvSpPr/>
          <p:nvPr/>
        </p:nvSpPr>
        <p:spPr>
          <a:xfrm>
            <a:off x="6315118" y="1203175"/>
            <a:ext cx="2051681" cy="2221706"/>
          </a:xfrm>
          <a:custGeom>
            <a:avLst/>
            <a:gdLst>
              <a:gd name="connsiteX0" fmla="*/ 0 w 1473517"/>
              <a:gd name="connsiteY0" fmla="*/ 0 h 1599247"/>
              <a:gd name="connsiteX1" fmla="*/ 1473518 w 1473517"/>
              <a:gd name="connsiteY1" fmla="*/ 0 h 1599247"/>
              <a:gd name="connsiteX2" fmla="*/ 1473518 w 1473517"/>
              <a:gd name="connsiteY2" fmla="*/ 1599248 h 1599247"/>
              <a:gd name="connsiteX3" fmla="*/ 0 w 1473517"/>
              <a:gd name="connsiteY3" fmla="*/ 1599248 h 1599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73517" h="1599247">
                <a:moveTo>
                  <a:pt x="0" y="0"/>
                </a:moveTo>
                <a:lnTo>
                  <a:pt x="1473518" y="0"/>
                </a:lnTo>
                <a:lnTo>
                  <a:pt x="1473518" y="1599248"/>
                </a:lnTo>
                <a:lnTo>
                  <a:pt x="0" y="1599248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50" name="Freeform: Shape 49">
            <a:extLst>
              <a:ext uri="{FF2B5EF4-FFF2-40B4-BE49-F238E27FC236}">
                <a16:creationId xmlns:a16="http://schemas.microsoft.com/office/drawing/2014/main" id="{982D95E0-B82B-4998-9EB3-71FABEAD79AD}"/>
              </a:ext>
            </a:extLst>
          </p:cNvPr>
          <p:cNvSpPr/>
          <p:nvPr/>
        </p:nvSpPr>
        <p:spPr>
          <a:xfrm>
            <a:off x="6306079" y="3831991"/>
            <a:ext cx="1970903" cy="2221706"/>
          </a:xfrm>
          <a:custGeom>
            <a:avLst/>
            <a:gdLst>
              <a:gd name="connsiteX0" fmla="*/ 0 w 1330642"/>
              <a:gd name="connsiteY0" fmla="*/ 0 h 1599247"/>
              <a:gd name="connsiteX1" fmla="*/ 1330643 w 1330642"/>
              <a:gd name="connsiteY1" fmla="*/ 0 h 1599247"/>
              <a:gd name="connsiteX2" fmla="*/ 1330643 w 1330642"/>
              <a:gd name="connsiteY2" fmla="*/ 1599248 h 1599247"/>
              <a:gd name="connsiteX3" fmla="*/ 0 w 1330642"/>
              <a:gd name="connsiteY3" fmla="*/ 1599248 h 15992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30642" h="1599247">
                <a:moveTo>
                  <a:pt x="0" y="0"/>
                </a:moveTo>
                <a:lnTo>
                  <a:pt x="1330643" y="0"/>
                </a:lnTo>
                <a:lnTo>
                  <a:pt x="1330643" y="1599248"/>
                </a:lnTo>
                <a:lnTo>
                  <a:pt x="0" y="1599248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54" name="文本框 7">
            <a:extLst>
              <a:ext uri="{FF2B5EF4-FFF2-40B4-BE49-F238E27FC236}">
                <a16:creationId xmlns:a16="http://schemas.microsoft.com/office/drawing/2014/main" id="{4AAE6250-0486-4266-B691-35B558E910EB}"/>
              </a:ext>
            </a:extLst>
          </p:cNvPr>
          <p:cNvSpPr txBox="1"/>
          <p:nvPr/>
        </p:nvSpPr>
        <p:spPr>
          <a:xfrm>
            <a:off x="8366799" y="1864709"/>
            <a:ext cx="967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56" name="文本框 7">
            <a:extLst>
              <a:ext uri="{FF2B5EF4-FFF2-40B4-BE49-F238E27FC236}">
                <a16:creationId xmlns:a16="http://schemas.microsoft.com/office/drawing/2014/main" id="{B92A4EC3-584C-4B35-8988-FF1A3B81D50E}"/>
              </a:ext>
            </a:extLst>
          </p:cNvPr>
          <p:cNvSpPr txBox="1"/>
          <p:nvPr/>
        </p:nvSpPr>
        <p:spPr>
          <a:xfrm>
            <a:off x="8276981" y="4505771"/>
            <a:ext cx="967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pS</a:t>
            </a:r>
            <a:r>
              <a:rPr lang="en-US" altLang="zh-CN" dirty="0"/>
              <a:t>*Q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3348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498908" y="511491"/>
            <a:ext cx="15418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1 Fig 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5913" y="4417386"/>
            <a:ext cx="1025191" cy="5639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/>
          <p:cNvSpPr txBox="1"/>
          <p:nvPr/>
        </p:nvSpPr>
        <p:spPr>
          <a:xfrm>
            <a:off x="2079215" y="2542170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2079215" y="4562315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079215" y="3756174"/>
            <a:ext cx="715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GlyRS</a:t>
            </a:r>
            <a:endParaRPr lang="zh-CN" altLang="en-US" dirty="0"/>
          </a:p>
        </p:txBody>
      </p:sp>
      <p:grpSp>
        <p:nvGrpSpPr>
          <p:cNvPr id="15" name="组合 14"/>
          <p:cNvGrpSpPr/>
          <p:nvPr/>
        </p:nvGrpSpPr>
        <p:grpSpPr>
          <a:xfrm>
            <a:off x="1055913" y="2134308"/>
            <a:ext cx="1023302" cy="1185057"/>
            <a:chOff x="1797741" y="2132732"/>
            <a:chExt cx="1023302" cy="1185057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7741" y="2132732"/>
              <a:ext cx="1023302" cy="11850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矩形 11"/>
            <p:cNvSpPr/>
            <p:nvPr/>
          </p:nvSpPr>
          <p:spPr>
            <a:xfrm>
              <a:off x="1803919" y="2682014"/>
              <a:ext cx="963994" cy="18466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1055914" y="3575519"/>
            <a:ext cx="1029901" cy="635847"/>
            <a:chOff x="1797742" y="3573943"/>
            <a:chExt cx="1029901" cy="635847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7742" y="3573943"/>
              <a:ext cx="1023302" cy="6358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矩形 12"/>
            <p:cNvSpPr/>
            <p:nvPr/>
          </p:nvSpPr>
          <p:spPr>
            <a:xfrm>
              <a:off x="1863649" y="3890920"/>
              <a:ext cx="963994" cy="18466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3894392" y="4606539"/>
            <a:ext cx="1084675" cy="1154762"/>
            <a:chOff x="4422272" y="4415810"/>
            <a:chExt cx="1084675" cy="1154762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22272" y="4415810"/>
              <a:ext cx="1084675" cy="115476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矩形 16"/>
            <p:cNvSpPr/>
            <p:nvPr/>
          </p:nvSpPr>
          <p:spPr>
            <a:xfrm>
              <a:off x="4423719" y="4973596"/>
              <a:ext cx="488092" cy="17299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3362943" y="3311563"/>
            <a:ext cx="1893288" cy="1248900"/>
            <a:chOff x="3965167" y="3070655"/>
            <a:chExt cx="1893288" cy="1248900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5167" y="3070655"/>
              <a:ext cx="1893288" cy="1248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矩形 20"/>
            <p:cNvSpPr/>
            <p:nvPr/>
          </p:nvSpPr>
          <p:spPr>
            <a:xfrm>
              <a:off x="4510216" y="3754598"/>
              <a:ext cx="401595" cy="2286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4" name="文本框 23"/>
          <p:cNvSpPr txBox="1"/>
          <p:nvPr/>
        </p:nvSpPr>
        <p:spPr>
          <a:xfrm>
            <a:off x="4926268" y="2287251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4962437" y="503077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5234397" y="3925167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-1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384436" y="508632"/>
            <a:ext cx="15616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1 Fig B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6471565" y="508632"/>
            <a:ext cx="15824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1 Fig C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3841593" y="1696188"/>
            <a:ext cx="1084675" cy="1551459"/>
            <a:chOff x="3841593" y="1696188"/>
            <a:chExt cx="1084675" cy="1551459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1593" y="1696188"/>
              <a:ext cx="1084675" cy="15514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0" name="矩形 29"/>
            <p:cNvSpPr/>
            <p:nvPr/>
          </p:nvSpPr>
          <p:spPr>
            <a:xfrm>
              <a:off x="3907992" y="2360141"/>
              <a:ext cx="843181" cy="1820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6094783" y="1696188"/>
            <a:ext cx="1619354" cy="1409992"/>
            <a:chOff x="6453130" y="1696188"/>
            <a:chExt cx="1619354" cy="1409992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3130" y="1696188"/>
              <a:ext cx="1619354" cy="14099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矩形 31"/>
            <p:cNvSpPr/>
            <p:nvPr/>
          </p:nvSpPr>
          <p:spPr>
            <a:xfrm>
              <a:off x="6471565" y="2360141"/>
              <a:ext cx="791242" cy="1820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6094783" y="3379734"/>
            <a:ext cx="1619354" cy="1054210"/>
            <a:chOff x="6453130" y="3379734"/>
            <a:chExt cx="1619354" cy="1054210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3130" y="3379734"/>
              <a:ext cx="1619354" cy="10542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5" name="矩形 34"/>
            <p:cNvSpPr/>
            <p:nvPr/>
          </p:nvSpPr>
          <p:spPr>
            <a:xfrm>
              <a:off x="6623222" y="3925167"/>
              <a:ext cx="710513" cy="1519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7" name="文本框 36"/>
          <p:cNvSpPr txBox="1"/>
          <p:nvPr/>
        </p:nvSpPr>
        <p:spPr>
          <a:xfrm>
            <a:off x="7732572" y="2266489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aseline="30000" dirty="0"/>
              <a:t>32</a:t>
            </a:r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7714137" y="3694486"/>
            <a:ext cx="11945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oomassie</a:t>
            </a:r>
            <a:endParaRPr lang="en-US" altLang="zh-CN" dirty="0"/>
          </a:p>
          <a:p>
            <a:r>
              <a:rPr lang="en-US" altLang="zh-CN" dirty="0"/>
              <a:t>blu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642762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771613" y="446848"/>
            <a:ext cx="15824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1 Fig D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3562002" y="1915535"/>
            <a:ext cx="906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3562002" y="4107258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6518189" y="2100201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CHK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518189" y="429192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K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6518189" y="1813353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CHK2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518189" y="4035302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K2</a:t>
            </a:r>
            <a:endParaRPr lang="zh-CN" altLang="en-US" dirty="0"/>
          </a:p>
        </p:txBody>
      </p:sp>
      <p:grpSp>
        <p:nvGrpSpPr>
          <p:cNvPr id="29" name="组合 28"/>
          <p:cNvGrpSpPr/>
          <p:nvPr/>
        </p:nvGrpSpPr>
        <p:grpSpPr>
          <a:xfrm>
            <a:off x="4876989" y="1378539"/>
            <a:ext cx="1641200" cy="1979658"/>
            <a:chOff x="4876989" y="1378539"/>
            <a:chExt cx="1641200" cy="1979658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6989" y="1378539"/>
              <a:ext cx="1641200" cy="19796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" name="矩形 22"/>
            <p:cNvSpPr/>
            <p:nvPr/>
          </p:nvSpPr>
          <p:spPr>
            <a:xfrm>
              <a:off x="4936525" y="1964959"/>
              <a:ext cx="1118286" cy="452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4876989" y="3562562"/>
            <a:ext cx="1641200" cy="2124839"/>
            <a:chOff x="4876989" y="3562562"/>
            <a:chExt cx="1641200" cy="2124839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6989" y="3562562"/>
              <a:ext cx="1641200" cy="21248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矩形 23"/>
            <p:cNvSpPr/>
            <p:nvPr/>
          </p:nvSpPr>
          <p:spPr>
            <a:xfrm>
              <a:off x="4988450" y="4066192"/>
              <a:ext cx="1118286" cy="452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1878516" y="1378539"/>
            <a:ext cx="1683486" cy="1980571"/>
            <a:chOff x="1878516" y="1378539"/>
            <a:chExt cx="1683486" cy="1980571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8516" y="1378539"/>
              <a:ext cx="1683486" cy="19805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5" name="矩形 24"/>
            <p:cNvSpPr/>
            <p:nvPr/>
          </p:nvSpPr>
          <p:spPr>
            <a:xfrm>
              <a:off x="2168611" y="1964959"/>
              <a:ext cx="982362" cy="40340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1878516" y="3562562"/>
            <a:ext cx="1683486" cy="2090655"/>
            <a:chOff x="1878516" y="3562562"/>
            <a:chExt cx="1683486" cy="2090655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8516" y="3562562"/>
              <a:ext cx="1683486" cy="20906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矩形 25"/>
            <p:cNvSpPr/>
            <p:nvPr/>
          </p:nvSpPr>
          <p:spPr>
            <a:xfrm>
              <a:off x="2123301" y="4104877"/>
              <a:ext cx="1027247" cy="40340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06567475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771613" y="446848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3257645" y="2296705"/>
            <a:ext cx="2080474" cy="631847"/>
            <a:chOff x="3257645" y="2296705"/>
            <a:chExt cx="2080474" cy="631847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7645" y="2296705"/>
              <a:ext cx="2080474" cy="6318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矩形 7"/>
            <p:cNvSpPr/>
            <p:nvPr/>
          </p:nvSpPr>
          <p:spPr>
            <a:xfrm>
              <a:off x="3771613" y="2508422"/>
              <a:ext cx="1223412" cy="1791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3266357" y="3137592"/>
            <a:ext cx="2071762" cy="1490332"/>
            <a:chOff x="3266357" y="3137592"/>
            <a:chExt cx="2071762" cy="1490332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66357" y="3137592"/>
              <a:ext cx="2071762" cy="14903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矩形 8"/>
            <p:cNvSpPr/>
            <p:nvPr/>
          </p:nvSpPr>
          <p:spPr>
            <a:xfrm>
              <a:off x="3699720" y="3525795"/>
              <a:ext cx="1051453" cy="18123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3699720" y="4727324"/>
            <a:ext cx="1203510" cy="1170850"/>
            <a:chOff x="3699720" y="4727324"/>
            <a:chExt cx="1203510" cy="117085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99720" y="4727324"/>
              <a:ext cx="1203510" cy="11708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/>
          </p:nvSpPr>
          <p:spPr>
            <a:xfrm>
              <a:off x="3771613" y="5245463"/>
              <a:ext cx="930133" cy="1667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4" name="文本框 13"/>
          <p:cNvSpPr txBox="1"/>
          <p:nvPr/>
        </p:nvSpPr>
        <p:spPr>
          <a:xfrm>
            <a:off x="5338119" y="2409568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γ</a:t>
            </a:r>
            <a:r>
              <a:rPr lang="en-US" altLang="zh-CN" dirty="0"/>
              <a:t>-H2AX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5345724" y="3341129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2AX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4995025" y="5144195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2193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771613" y="446848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25627" y="4211260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2922377" y="2857062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2947089" y="3916750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MNA/LMNC</a:t>
            </a:r>
            <a:endParaRPr lang="zh-CN" altLang="en-US" dirty="0"/>
          </a:p>
        </p:txBody>
      </p:sp>
      <p:grpSp>
        <p:nvGrpSpPr>
          <p:cNvPr id="14" name="组合 13"/>
          <p:cNvGrpSpPr/>
          <p:nvPr/>
        </p:nvGrpSpPr>
        <p:grpSpPr>
          <a:xfrm>
            <a:off x="1092295" y="2399463"/>
            <a:ext cx="1854794" cy="1284531"/>
            <a:chOff x="1092295" y="2399463"/>
            <a:chExt cx="1854794" cy="1284531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2295" y="2399463"/>
              <a:ext cx="1854794" cy="12845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/>
          </p:nvSpPr>
          <p:spPr>
            <a:xfrm>
              <a:off x="1340708" y="2940908"/>
              <a:ext cx="1402492" cy="1977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1092295" y="3793838"/>
            <a:ext cx="1854794" cy="997022"/>
            <a:chOff x="1092295" y="3793838"/>
            <a:chExt cx="1854794" cy="997022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2295" y="3793838"/>
              <a:ext cx="1854794" cy="9970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矩形 10"/>
            <p:cNvSpPr/>
            <p:nvPr/>
          </p:nvSpPr>
          <p:spPr>
            <a:xfrm>
              <a:off x="1184189" y="4040928"/>
              <a:ext cx="1402492" cy="1977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矩形 11"/>
            <p:cNvSpPr/>
            <p:nvPr/>
          </p:nvSpPr>
          <p:spPr>
            <a:xfrm>
              <a:off x="1184189" y="4297072"/>
              <a:ext cx="1402492" cy="1977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5" name="文本框 14"/>
          <p:cNvSpPr txBox="1"/>
          <p:nvPr/>
        </p:nvSpPr>
        <p:spPr>
          <a:xfrm>
            <a:off x="1883096" y="18162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9228" y="3441213"/>
            <a:ext cx="1892342" cy="9510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9227" y="2315750"/>
            <a:ext cx="1892342" cy="9377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9227" y="4622259"/>
            <a:ext cx="1892342" cy="7527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文本框 19"/>
          <p:cNvSpPr txBox="1"/>
          <p:nvPr/>
        </p:nvSpPr>
        <p:spPr>
          <a:xfrm>
            <a:off x="6981569" y="3943904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990879" y="2496839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981568" y="3699355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MNA/LMNC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6981569" y="4943879"/>
            <a:ext cx="209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  <a:p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981568" y="4680796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MNA/LMNC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5876540" y="184257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849209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926345" y="171121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4245713" y="459205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249150" y="171121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1780" y="4131028"/>
            <a:ext cx="2565334" cy="10609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4446" y="2637064"/>
            <a:ext cx="1165277" cy="13765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7679723" y="3140446"/>
            <a:ext cx="10191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IRT2-V5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7797114" y="4417311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  <p:grpSp>
        <p:nvGrpSpPr>
          <p:cNvPr id="15" name="组合 14"/>
          <p:cNvGrpSpPr/>
          <p:nvPr/>
        </p:nvGrpSpPr>
        <p:grpSpPr>
          <a:xfrm>
            <a:off x="5380061" y="2637064"/>
            <a:ext cx="1017370" cy="1376097"/>
            <a:chOff x="5380061" y="2637064"/>
            <a:chExt cx="1017370" cy="1376097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0061" y="2637064"/>
              <a:ext cx="1017370" cy="13760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矩形 13"/>
            <p:cNvSpPr/>
            <p:nvPr/>
          </p:nvSpPr>
          <p:spPr>
            <a:xfrm>
              <a:off x="5684108" y="3249827"/>
              <a:ext cx="648730" cy="12974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7" name="图片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498" y="3007727"/>
            <a:ext cx="1082525" cy="11438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499" y="4230131"/>
            <a:ext cx="1083076" cy="11130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497" y="5416543"/>
            <a:ext cx="1082525" cy="7682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3407022" y="2260410"/>
            <a:ext cx="700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IRT2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3411793" y="3274600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3407022" y="4571970"/>
            <a:ext cx="700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IRT2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3407022" y="5567333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grpSp>
        <p:nvGrpSpPr>
          <p:cNvPr id="28" name="组合 27"/>
          <p:cNvGrpSpPr/>
          <p:nvPr/>
        </p:nvGrpSpPr>
        <p:grpSpPr>
          <a:xfrm>
            <a:off x="2324498" y="2112608"/>
            <a:ext cx="1082525" cy="750619"/>
            <a:chOff x="2324498" y="2112608"/>
            <a:chExt cx="1082525" cy="750619"/>
          </a:xfrm>
        </p:grpSpPr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4498" y="2112608"/>
              <a:ext cx="1082525" cy="7506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矩形 26"/>
            <p:cNvSpPr/>
            <p:nvPr/>
          </p:nvSpPr>
          <p:spPr>
            <a:xfrm>
              <a:off x="2576384" y="2310714"/>
              <a:ext cx="500448" cy="13436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1109973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4030195" y="505123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6 Fi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876024" y="5195991"/>
            <a:ext cx="1725350" cy="607910"/>
            <a:chOff x="2706350" y="4584806"/>
            <a:chExt cx="2647689" cy="1070342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6350" y="4584806"/>
              <a:ext cx="2647689" cy="10703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矩形 5"/>
            <p:cNvSpPr/>
            <p:nvPr/>
          </p:nvSpPr>
          <p:spPr>
            <a:xfrm>
              <a:off x="2971800" y="4826000"/>
              <a:ext cx="1758950" cy="2159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1876024" y="3922806"/>
            <a:ext cx="1725350" cy="1138264"/>
            <a:chOff x="2668849" y="3130792"/>
            <a:chExt cx="1725350" cy="1138264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8849" y="3130792"/>
              <a:ext cx="1725350" cy="11382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矩形 23"/>
            <p:cNvSpPr/>
            <p:nvPr/>
          </p:nvSpPr>
          <p:spPr>
            <a:xfrm>
              <a:off x="2850905" y="3689350"/>
              <a:ext cx="1352795" cy="1587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5009387" y="4102519"/>
            <a:ext cx="1712571" cy="1093472"/>
            <a:chOff x="4996687" y="4196078"/>
            <a:chExt cx="1712571" cy="1093472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6687" y="4196078"/>
              <a:ext cx="1712571" cy="10934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7" name="矩形 26"/>
            <p:cNvSpPr/>
            <p:nvPr/>
          </p:nvSpPr>
          <p:spPr>
            <a:xfrm>
              <a:off x="5310757" y="4617401"/>
              <a:ext cx="1286893" cy="1768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9" name="图片 28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1802" y="1733122"/>
            <a:ext cx="1725350" cy="106249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3" name="组合 32"/>
          <p:cNvGrpSpPr/>
          <p:nvPr/>
        </p:nvGrpSpPr>
        <p:grpSpPr>
          <a:xfrm>
            <a:off x="5009386" y="2188192"/>
            <a:ext cx="1712571" cy="955854"/>
            <a:chOff x="5009386" y="2188192"/>
            <a:chExt cx="1712571" cy="955854"/>
          </a:xfrm>
        </p:grpSpPr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9386" y="2188192"/>
              <a:ext cx="1712571" cy="9558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矩形 31"/>
            <p:cNvSpPr/>
            <p:nvPr/>
          </p:nvSpPr>
          <p:spPr>
            <a:xfrm>
              <a:off x="5054600" y="2355850"/>
              <a:ext cx="1422400" cy="31026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5009385" y="3233902"/>
            <a:ext cx="1712571" cy="688904"/>
            <a:chOff x="5009385" y="3233902"/>
            <a:chExt cx="1712571" cy="688904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9385" y="3233902"/>
              <a:ext cx="1712571" cy="6889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4" name="矩形 33"/>
            <p:cNvSpPr/>
            <p:nvPr/>
          </p:nvSpPr>
          <p:spPr>
            <a:xfrm>
              <a:off x="5054600" y="3285864"/>
              <a:ext cx="1422400" cy="31026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6" name="文本框 35"/>
          <p:cNvSpPr txBox="1"/>
          <p:nvPr/>
        </p:nvSpPr>
        <p:spPr>
          <a:xfrm>
            <a:off x="5009385" y="1507282"/>
            <a:ext cx="1577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P: Flag (SerRS)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2126939" y="1228869"/>
            <a:ext cx="1215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ell lysates</a:t>
            </a:r>
            <a:endParaRPr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3554089" y="2011433"/>
            <a:ext cx="74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Myc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3554089" y="2930535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-1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3630239" y="4376073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  <p:sp>
        <p:nvSpPr>
          <p:cNvPr id="41" name="文本框 40"/>
          <p:cNvSpPr txBox="1"/>
          <p:nvPr/>
        </p:nvSpPr>
        <p:spPr>
          <a:xfrm>
            <a:off x="3597152" y="5195991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grpSp>
        <p:nvGrpSpPr>
          <p:cNvPr id="43" name="组合 42"/>
          <p:cNvGrpSpPr/>
          <p:nvPr/>
        </p:nvGrpSpPr>
        <p:grpSpPr>
          <a:xfrm>
            <a:off x="1871802" y="2891326"/>
            <a:ext cx="1725350" cy="962986"/>
            <a:chOff x="1871802" y="2891326"/>
            <a:chExt cx="1725350" cy="962986"/>
          </a:xfrm>
        </p:grpSpPr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1802" y="2891326"/>
              <a:ext cx="1725350" cy="9629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矩形 41"/>
            <p:cNvSpPr/>
            <p:nvPr/>
          </p:nvSpPr>
          <p:spPr>
            <a:xfrm>
              <a:off x="2228850" y="2984500"/>
              <a:ext cx="1182025" cy="24940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44" name="文本框 43"/>
          <p:cNvSpPr txBox="1"/>
          <p:nvPr/>
        </p:nvSpPr>
        <p:spPr>
          <a:xfrm>
            <a:off x="6706700" y="2303933"/>
            <a:ext cx="749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-Myc</a:t>
            </a:r>
            <a:endParaRPr lang="zh-CN" altLang="en-US" dirty="0"/>
          </a:p>
        </p:txBody>
      </p:sp>
      <p:sp>
        <p:nvSpPr>
          <p:cNvPr id="45" name="文本框 44"/>
          <p:cNvSpPr txBox="1"/>
          <p:nvPr/>
        </p:nvSpPr>
        <p:spPr>
          <a:xfrm>
            <a:off x="6720588" y="3262406"/>
            <a:ext cx="811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IF-1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zh-CN" altLang="en-US" dirty="0"/>
          </a:p>
        </p:txBody>
      </p:sp>
      <p:sp>
        <p:nvSpPr>
          <p:cNvPr id="46" name="文本框 45"/>
          <p:cNvSpPr txBox="1"/>
          <p:nvPr/>
        </p:nvSpPr>
        <p:spPr>
          <a:xfrm>
            <a:off x="6706700" y="4413483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9259494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4030195" y="505123"/>
            <a:ext cx="14424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8A Fi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1792" y="2516886"/>
            <a:ext cx="1943608" cy="8052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0716" y="3429161"/>
            <a:ext cx="814684" cy="11174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7691852" y="2641600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7645400" y="3618548"/>
            <a:ext cx="536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R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7610999" y="3897908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13450" y="1841500"/>
            <a:ext cx="14999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shATM+shATR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9482" y="3616901"/>
            <a:ext cx="2927109" cy="10880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文本框 12"/>
          <p:cNvSpPr txBox="1"/>
          <p:nvPr/>
        </p:nvSpPr>
        <p:spPr>
          <a:xfrm>
            <a:off x="4870765" y="3695862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707200" y="2826266"/>
            <a:ext cx="536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R</a:t>
            </a:r>
            <a:endParaRPr lang="zh-CN" altLang="en-US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803" y="2615614"/>
            <a:ext cx="1143597" cy="7906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3589" y="2210832"/>
            <a:ext cx="1464366" cy="13186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文本框 17"/>
          <p:cNvSpPr txBox="1"/>
          <p:nvPr/>
        </p:nvSpPr>
        <p:spPr>
          <a:xfrm>
            <a:off x="2928417" y="2570784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2034136" y="1797807"/>
            <a:ext cx="820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shATM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3766348" y="2202589"/>
            <a:ext cx="74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shAT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034360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A187CC1C-4826-4D54-AAAE-A07A12C3A4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1964" y="2055610"/>
            <a:ext cx="2493817" cy="9672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8987E2B-9208-4467-88CD-5F8822B34F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1964" y="3203143"/>
            <a:ext cx="2493817" cy="8415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5B971E8-01E6-40D0-9729-141DBEC7F22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1963" y="4124278"/>
            <a:ext cx="2493817" cy="8984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62AD46A4-9D5C-4761-9F03-0D166489A3C5}"/>
              </a:ext>
            </a:extLst>
          </p:cNvPr>
          <p:cNvSpPr txBox="1"/>
          <p:nvPr/>
        </p:nvSpPr>
        <p:spPr>
          <a:xfrm>
            <a:off x="3724099" y="180580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E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25185A2-9355-4338-A07D-496292823625}"/>
              </a:ext>
            </a:extLst>
          </p:cNvPr>
          <p:cNvSpPr txBox="1"/>
          <p:nvPr/>
        </p:nvSpPr>
        <p:spPr>
          <a:xfrm>
            <a:off x="5785657" y="1145371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*Q</a:t>
            </a:r>
            <a:endParaRPr lang="zh-CN" altLang="en-US" dirty="0"/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FEC31506-7C30-49DD-8000-89D241D6BD64}"/>
              </a:ext>
            </a:extLst>
          </p:cNvPr>
          <p:cNvGrpSpPr/>
          <p:nvPr/>
        </p:nvGrpSpPr>
        <p:grpSpPr>
          <a:xfrm>
            <a:off x="3241965" y="916932"/>
            <a:ext cx="2543692" cy="1036807"/>
            <a:chOff x="3241965" y="916932"/>
            <a:chExt cx="2543692" cy="1036807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7A633D73-9BCF-4EB6-8B78-D4E7A9288E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1965" y="916932"/>
              <a:ext cx="2493818" cy="10368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0" name="直接箭头连接符 19">
              <a:extLst>
                <a:ext uri="{FF2B5EF4-FFF2-40B4-BE49-F238E27FC236}">
                  <a16:creationId xmlns:a16="http://schemas.microsoft.com/office/drawing/2014/main" id="{0638717A-ED39-4EB4-AC76-30C23BE0A3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11089" y="1330037"/>
              <a:ext cx="17456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A1FA340C-FF4F-4456-9FDD-71A73D14D685}"/>
              </a:ext>
            </a:extLst>
          </p:cNvPr>
          <p:cNvSpPr txBox="1"/>
          <p:nvPr/>
        </p:nvSpPr>
        <p:spPr>
          <a:xfrm>
            <a:off x="5785657" y="2266589"/>
            <a:ext cx="63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aaRS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5785657" y="3439184"/>
            <a:ext cx="1553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ATM (s1981)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C67B1E9-0128-4C4C-B4E6-C49E0A517435}"/>
              </a:ext>
            </a:extLst>
          </p:cNvPr>
          <p:cNvSpPr txBox="1"/>
          <p:nvPr/>
        </p:nvSpPr>
        <p:spPr>
          <a:xfrm>
            <a:off x="5785657" y="5155615"/>
            <a:ext cx="1504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RPA32 (S33)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5802167" y="4260194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F5DDD52-7B51-425F-80A8-B14A0EF2DEEC}"/>
              </a:ext>
            </a:extLst>
          </p:cNvPr>
          <p:cNvSpPr txBox="1"/>
          <p:nvPr/>
        </p:nvSpPr>
        <p:spPr>
          <a:xfrm>
            <a:off x="5821003" y="6210593"/>
            <a:ext cx="778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PA32</a:t>
            </a:r>
            <a:endParaRPr lang="zh-CN" altLang="en-US" dirty="0"/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2B3482DD-7EFD-4A1C-863D-D9C431A881F0}"/>
              </a:ext>
            </a:extLst>
          </p:cNvPr>
          <p:cNvGrpSpPr/>
          <p:nvPr/>
        </p:nvGrpSpPr>
        <p:grpSpPr>
          <a:xfrm>
            <a:off x="3241963" y="5146181"/>
            <a:ext cx="2621278" cy="710881"/>
            <a:chOff x="3241963" y="5146181"/>
            <a:chExt cx="2621278" cy="71088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C17F14F-267E-448B-8D50-3A70745DB2A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1963" y="5146181"/>
              <a:ext cx="2493817" cy="7108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7" name="直接箭头连接符 26">
              <a:extLst>
                <a:ext uri="{FF2B5EF4-FFF2-40B4-BE49-F238E27FC236}">
                  <a16:creationId xmlns:a16="http://schemas.microsoft.com/office/drawing/2014/main" id="{676B25E5-1E57-4468-93D8-4C21B5BD22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88673" y="5340281"/>
              <a:ext cx="17456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68C8E96F-DB04-4B87-A0A5-AEEE2F48C2BF}"/>
              </a:ext>
            </a:extLst>
          </p:cNvPr>
          <p:cNvGrpSpPr/>
          <p:nvPr/>
        </p:nvGrpSpPr>
        <p:grpSpPr>
          <a:xfrm>
            <a:off x="3241963" y="5980537"/>
            <a:ext cx="2630978" cy="669481"/>
            <a:chOff x="3241963" y="5980537"/>
            <a:chExt cx="2630978" cy="669481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F50EA238-8B1B-46B8-A92E-9D93C790E61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1963" y="5980537"/>
              <a:ext cx="2493817" cy="6694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058DFC21-C9A1-488E-AC70-AABC3F9ED9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8373" y="6495011"/>
              <a:ext cx="17456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718922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69044DD-ED0F-47FC-A36C-97D4C3780CC2}"/>
              </a:ext>
            </a:extLst>
          </p:cNvPr>
          <p:cNvSpPr txBox="1"/>
          <p:nvPr/>
        </p:nvSpPr>
        <p:spPr>
          <a:xfrm>
            <a:off x="3848486" y="580630"/>
            <a:ext cx="12041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F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2F3FFB6-2399-4A8F-8DA2-69EC0EC4B6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9096" y="4806692"/>
            <a:ext cx="1465009" cy="8952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B9F76E1-6003-45F8-8DB7-02492DAB5D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434" y="1956192"/>
            <a:ext cx="1438977" cy="15641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96EA17D-7D20-4A66-B935-994E0412F30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433" y="3644177"/>
            <a:ext cx="1438977" cy="819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C8DA680-491F-4040-AEB2-24C678227A7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432" y="4558703"/>
            <a:ext cx="1438977" cy="6002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2113" y="3731291"/>
            <a:ext cx="1438976" cy="8274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433" y="5254334"/>
            <a:ext cx="1438976" cy="6479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3239409" y="4711276"/>
            <a:ext cx="1553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ATM (s1981)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3239409" y="5406907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3289038" y="2513219"/>
            <a:ext cx="906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3303199" y="3869066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6681089" y="2179801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CHK1(s345)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730685" y="3046668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K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6658696" y="3913535"/>
            <a:ext cx="1247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53 (s15)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6806827" y="5263566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53</a:t>
            </a:r>
            <a:endParaRPr lang="zh-CN" altLang="en-US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0638717A-ED39-4EB4-AC76-30C23BE0A39D}"/>
              </a:ext>
            </a:extLst>
          </p:cNvPr>
          <p:cNvCxnSpPr>
            <a:cxnSpLocks/>
          </p:cNvCxnSpPr>
          <p:nvPr/>
        </p:nvCxnSpPr>
        <p:spPr>
          <a:xfrm flipH="1">
            <a:off x="3205466" y="2738244"/>
            <a:ext cx="17456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图片 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2113" y="2876482"/>
            <a:ext cx="1443880" cy="709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2113" y="2013159"/>
            <a:ext cx="1443880" cy="68472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0638717A-ED39-4EB4-AC76-30C23BE0A39D}"/>
              </a:ext>
            </a:extLst>
          </p:cNvPr>
          <p:cNvCxnSpPr>
            <a:cxnSpLocks/>
          </p:cNvCxnSpPr>
          <p:nvPr/>
        </p:nvCxnSpPr>
        <p:spPr>
          <a:xfrm flipH="1">
            <a:off x="6681089" y="5438999"/>
            <a:ext cx="17456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3653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815540" y="255394"/>
            <a:ext cx="12634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3270710" y="1681426"/>
            <a:ext cx="1339670" cy="1239342"/>
            <a:chOff x="1447980" y="2686217"/>
            <a:chExt cx="1339670" cy="1239342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7980" y="2686217"/>
              <a:ext cx="1339670" cy="12393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矩形 1"/>
            <p:cNvSpPr/>
            <p:nvPr/>
          </p:nvSpPr>
          <p:spPr>
            <a:xfrm>
              <a:off x="1638300" y="3200400"/>
              <a:ext cx="876300" cy="2159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3278786" y="3089655"/>
            <a:ext cx="1339670" cy="1189426"/>
            <a:chOff x="1574980" y="3772051"/>
            <a:chExt cx="1339670" cy="1189426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4980" y="3772051"/>
              <a:ext cx="1339670" cy="11894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矩形 6"/>
            <p:cNvSpPr/>
            <p:nvPr/>
          </p:nvSpPr>
          <p:spPr>
            <a:xfrm>
              <a:off x="1714500" y="4457700"/>
              <a:ext cx="920750" cy="1905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959310" y="1641681"/>
            <a:ext cx="1339670" cy="1428981"/>
            <a:chOff x="1682930" y="1896543"/>
            <a:chExt cx="1339670" cy="1428981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82930" y="1896543"/>
              <a:ext cx="1339670" cy="14289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/>
          </p:nvSpPr>
          <p:spPr>
            <a:xfrm>
              <a:off x="1822450" y="2336800"/>
              <a:ext cx="876300" cy="2730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969964" y="3365639"/>
            <a:ext cx="1339670" cy="1316371"/>
            <a:chOff x="1682930" y="3378367"/>
            <a:chExt cx="1339670" cy="1316371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82930" y="3378367"/>
              <a:ext cx="1339670" cy="13163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矩形 12"/>
            <p:cNvSpPr/>
            <p:nvPr/>
          </p:nvSpPr>
          <p:spPr>
            <a:xfrm>
              <a:off x="1765300" y="3765550"/>
              <a:ext cx="882650" cy="3429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5" name="图片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427" y="2071551"/>
            <a:ext cx="1408870" cy="617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427" y="2920768"/>
            <a:ext cx="1408871" cy="64305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组合 19"/>
          <p:cNvGrpSpPr/>
          <p:nvPr/>
        </p:nvGrpSpPr>
        <p:grpSpPr>
          <a:xfrm>
            <a:off x="3128646" y="4827833"/>
            <a:ext cx="1694845" cy="1174913"/>
            <a:chOff x="3609101" y="4927437"/>
            <a:chExt cx="1694845" cy="1174913"/>
          </a:xfrm>
        </p:grpSpPr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101" y="4927437"/>
              <a:ext cx="1694845" cy="11749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矩形 18"/>
            <p:cNvSpPr/>
            <p:nvPr/>
          </p:nvSpPr>
          <p:spPr>
            <a:xfrm>
              <a:off x="3869352" y="5457743"/>
              <a:ext cx="962998" cy="20010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4587181" y="2084758"/>
            <a:ext cx="1553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ATM (s1981)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4587181" y="3638407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2222436" y="1995745"/>
            <a:ext cx="906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2249960" y="3702031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7469153" y="2100201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CHK1(s345)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7606985" y="3070662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HK1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4776912" y="5230623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29922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69044DD-ED0F-47FC-A36C-97D4C3780CC2}"/>
              </a:ext>
            </a:extLst>
          </p:cNvPr>
          <p:cNvSpPr txBox="1"/>
          <p:nvPr/>
        </p:nvSpPr>
        <p:spPr>
          <a:xfrm>
            <a:off x="3670474" y="675880"/>
            <a:ext cx="12442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H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2978428" y="4089508"/>
            <a:ext cx="2552422" cy="991798"/>
            <a:chOff x="2978428" y="4089508"/>
            <a:chExt cx="2552422" cy="991798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8428" y="4089508"/>
              <a:ext cx="2552422" cy="9917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" name="矩形 2"/>
            <p:cNvSpPr/>
            <p:nvPr/>
          </p:nvSpPr>
          <p:spPr>
            <a:xfrm>
              <a:off x="4292600" y="4362450"/>
              <a:ext cx="1104900" cy="3619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2978428" y="2463969"/>
            <a:ext cx="2552422" cy="1238246"/>
            <a:chOff x="2978428" y="2463969"/>
            <a:chExt cx="2552422" cy="1238246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8428" y="2463969"/>
              <a:ext cx="2552422" cy="12382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矩形 6"/>
            <p:cNvSpPr/>
            <p:nvPr/>
          </p:nvSpPr>
          <p:spPr>
            <a:xfrm>
              <a:off x="4273550" y="2819400"/>
              <a:ext cx="863600" cy="2667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9" name="文本框 8"/>
          <p:cNvSpPr txBox="1"/>
          <p:nvPr/>
        </p:nvSpPr>
        <p:spPr>
          <a:xfrm>
            <a:off x="5530850" y="2713760"/>
            <a:ext cx="1355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erRS-Flag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5530849" y="4288560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495298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890354" y="371773"/>
            <a:ext cx="10839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1I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5410349" y="1382842"/>
            <a:ext cx="2387301" cy="1424356"/>
            <a:chOff x="3003699" y="2578213"/>
            <a:chExt cx="2387301" cy="1424356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3699" y="2578213"/>
              <a:ext cx="2387301" cy="14243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矩形 3"/>
            <p:cNvSpPr/>
            <p:nvPr/>
          </p:nvSpPr>
          <p:spPr>
            <a:xfrm>
              <a:off x="3441700" y="3098800"/>
              <a:ext cx="1587500" cy="3873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5410349" y="3046544"/>
            <a:ext cx="2387301" cy="1841270"/>
            <a:chOff x="3003699" y="4241915"/>
            <a:chExt cx="2387301" cy="184127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3699" y="4241915"/>
              <a:ext cx="2387301" cy="18412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矩形 5"/>
            <p:cNvSpPr/>
            <p:nvPr/>
          </p:nvSpPr>
          <p:spPr>
            <a:xfrm>
              <a:off x="3213100" y="4775200"/>
              <a:ext cx="1993900" cy="3873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9" name="图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4282" y="3300512"/>
            <a:ext cx="2416418" cy="13940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7797650" y="1903429"/>
            <a:ext cx="609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M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1D4F0AB-AB6D-444C-A20B-119E7554EED3}"/>
              </a:ext>
            </a:extLst>
          </p:cNvPr>
          <p:cNvSpPr txBox="1"/>
          <p:nvPr/>
        </p:nvSpPr>
        <p:spPr>
          <a:xfrm>
            <a:off x="3710700" y="1830645"/>
            <a:ext cx="906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SerRS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3710700" y="3645309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7765227" y="3579829"/>
            <a:ext cx="536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TR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AF391FF-2DFD-46BC-BDAE-71D6BC4DDBE6}"/>
              </a:ext>
            </a:extLst>
          </p:cNvPr>
          <p:cNvSpPr txBox="1"/>
          <p:nvPr/>
        </p:nvSpPr>
        <p:spPr>
          <a:xfrm>
            <a:off x="3710700" y="543491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grpSp>
        <p:nvGrpSpPr>
          <p:cNvPr id="19" name="组合 18"/>
          <p:cNvGrpSpPr/>
          <p:nvPr/>
        </p:nvGrpSpPr>
        <p:grpSpPr>
          <a:xfrm>
            <a:off x="1294282" y="4797605"/>
            <a:ext cx="2416418" cy="1643957"/>
            <a:chOff x="1294282" y="4797605"/>
            <a:chExt cx="2416418" cy="1643957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4282" y="4797605"/>
              <a:ext cx="2416418" cy="16439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矩形 16"/>
            <p:cNvSpPr/>
            <p:nvPr/>
          </p:nvSpPr>
          <p:spPr>
            <a:xfrm>
              <a:off x="1911350" y="5434917"/>
              <a:ext cx="1657350" cy="2864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1294282" y="1382842"/>
            <a:ext cx="2416418" cy="1814664"/>
            <a:chOff x="1294282" y="1382842"/>
            <a:chExt cx="2416418" cy="1814664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4282" y="1382842"/>
              <a:ext cx="2416418" cy="18146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矩形 17"/>
            <p:cNvSpPr/>
            <p:nvPr/>
          </p:nvSpPr>
          <p:spPr>
            <a:xfrm>
              <a:off x="1771650" y="1913544"/>
              <a:ext cx="1657350" cy="2864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2973786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1379793" y="879773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309" y="4229190"/>
            <a:ext cx="1752381" cy="14068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5309" y="2086867"/>
            <a:ext cx="1752381" cy="18793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2867690" y="3026549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2867690" y="4857750"/>
            <a:ext cx="1142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5678743" y="879773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2B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5100922" y="2086867"/>
            <a:ext cx="2154438" cy="1712357"/>
            <a:chOff x="5100922" y="2086867"/>
            <a:chExt cx="2154438" cy="1712357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0922" y="2086867"/>
              <a:ext cx="2154438" cy="17123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矩形 11"/>
            <p:cNvSpPr/>
            <p:nvPr/>
          </p:nvSpPr>
          <p:spPr>
            <a:xfrm>
              <a:off x="5340350" y="2870200"/>
              <a:ext cx="1365250" cy="381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5100922" y="3991703"/>
            <a:ext cx="2280134" cy="1644328"/>
            <a:chOff x="5100922" y="3991703"/>
            <a:chExt cx="2280134" cy="1644328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0922" y="3991703"/>
              <a:ext cx="2280134" cy="16443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矩形 13"/>
            <p:cNvSpPr/>
            <p:nvPr/>
          </p:nvSpPr>
          <p:spPr>
            <a:xfrm>
              <a:off x="5340350" y="4997450"/>
              <a:ext cx="1263650" cy="4953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7381056" y="4846419"/>
            <a:ext cx="11945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oomassie</a:t>
            </a:r>
            <a:endParaRPr lang="en-US" altLang="zh-CN" dirty="0"/>
          </a:p>
          <a:p>
            <a:r>
              <a:rPr lang="en-US" altLang="zh-CN" dirty="0"/>
              <a:t>blue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7243891" y="2841883"/>
            <a:ext cx="116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-Fla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284461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3966695" y="244773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3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651102" y="1346200"/>
            <a:ext cx="5854598" cy="4908550"/>
            <a:chOff x="1651102" y="1346200"/>
            <a:chExt cx="5854598" cy="490855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1102" y="1346200"/>
              <a:ext cx="5854598" cy="490520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矩形 5"/>
            <p:cNvSpPr/>
            <p:nvPr/>
          </p:nvSpPr>
          <p:spPr>
            <a:xfrm>
              <a:off x="1778000" y="1511300"/>
              <a:ext cx="1504950" cy="47434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矩形 6"/>
            <p:cNvSpPr/>
            <p:nvPr/>
          </p:nvSpPr>
          <p:spPr>
            <a:xfrm>
              <a:off x="4597399" y="1511300"/>
              <a:ext cx="1419999" cy="47434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矩形 7"/>
            <p:cNvSpPr/>
            <p:nvPr/>
          </p:nvSpPr>
          <p:spPr>
            <a:xfrm>
              <a:off x="6017399" y="1511300"/>
              <a:ext cx="1354951" cy="47434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1936750" y="973522"/>
            <a:ext cx="9237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r>
              <a:rPr lang="en-US" altLang="zh-CN" baseline="30000" dirty="0"/>
              <a:t>WT</a:t>
            </a:r>
            <a:endParaRPr lang="zh-CN" altLang="en-US" baseline="30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4845508" y="973522"/>
            <a:ext cx="8917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SerRS</a:t>
            </a:r>
            <a:r>
              <a:rPr lang="en-US" altLang="zh-CN" baseline="30000" dirty="0" err="1"/>
              <a:t>AA</a:t>
            </a:r>
            <a:endParaRPr lang="zh-CN" altLang="en-US" baseline="30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6232984" y="973522"/>
            <a:ext cx="903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SerRS</a:t>
            </a:r>
            <a:r>
              <a:rPr lang="en-US" altLang="zh-CN" baseline="30000" dirty="0" err="1"/>
              <a:t>DD</a:t>
            </a:r>
            <a:endParaRPr lang="zh-CN" alt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34636097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1778064" y="1433128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4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25" y="2456931"/>
            <a:ext cx="2585090" cy="10528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754" y="2456931"/>
            <a:ext cx="2568446" cy="10425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B8FB862-B08C-4B73-9CFC-F3048577D51A}"/>
              </a:ext>
            </a:extLst>
          </p:cNvPr>
          <p:cNvSpPr txBox="1"/>
          <p:nvPr/>
        </p:nvSpPr>
        <p:spPr>
          <a:xfrm>
            <a:off x="5419271" y="1445470"/>
            <a:ext cx="1223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 4B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25" y="3987714"/>
            <a:ext cx="2585090" cy="1211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078" y="3987714"/>
            <a:ext cx="2568446" cy="11735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3682315" y="2774778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3682315" y="443567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7308864" y="2774778"/>
            <a:ext cx="713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erRS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7348524" y="438982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70626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6</TotalTime>
  <Words>220</Words>
  <Application>Microsoft Macintosh PowerPoint</Application>
  <PresentationFormat>On-screen Show (4:3)</PresentationFormat>
  <Paragraphs>130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4" baseType="lpstr">
      <vt:lpstr>Arial</vt:lpstr>
      <vt:lpstr>Calibri</vt:lpstr>
      <vt:lpstr>Calibri Light</vt:lpstr>
      <vt:lpstr>Symbo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Eric</dc:creator>
  <cp:lastModifiedBy>Xiang-Lei Yang</cp:lastModifiedBy>
  <cp:revision>82</cp:revision>
  <dcterms:created xsi:type="dcterms:W3CDTF">2020-10-31T04:53:19Z</dcterms:created>
  <dcterms:modified xsi:type="dcterms:W3CDTF">2020-11-01T21:18:54Z</dcterms:modified>
</cp:coreProperties>
</file>